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3BC4CC-C6C8-486D-9D79-BB9648AF1CA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62E420-A793-471F-B7AB-6FD506DA19D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457916-6BF6-422B-B4AD-1891898F7E9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69BED8-D121-4BC5-9421-6641570C756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E0EC2A-F8EA-4A07-82EB-450FB39D3F5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53DC20-DC82-4CBB-85D4-754F7671C8F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665D4D-6502-4D18-A9F8-3BF1DF0C4E3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9B48CA-C6B8-4B3B-AEBD-D6B20167462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40978A-E4EF-4707-875B-194D3035BC6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DBCA94-60E6-41F8-A745-06F29204C49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1F1536-FF48-4DB0-8190-498BC797919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F7499D-5E75-49D9-A1CE-F2F0477E7C4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790C975-F055-4F34-AB7B-FAF4122D8932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177840" y="1428840"/>
          <a:ext cx="6572160" cy="2428920"/>
        </p:xfrm>
        <a:graphic>
          <a:graphicData uri="http://schemas.openxmlformats.org/drawingml/2006/table">
            <a:tbl>
              <a:tblPr/>
              <a:tblGrid>
                <a:gridCol w="912600"/>
                <a:gridCol w="830520"/>
                <a:gridCol w="1396800"/>
                <a:gridCol w="1184400"/>
                <a:gridCol w="1122480"/>
                <a:gridCol w="1125360"/>
              </a:tblGrid>
              <a:tr h="279360">
                <a:tc gridSpan="2" rowSpan="2"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 row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hoot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oot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274680">
                <a:tc vMerge="1" grid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5712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aw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,257,88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,645,73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,677,31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,897,05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347760">
                <a:tc rowSpan="2"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rimmed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otal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,211,93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,880,97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,601,04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,205,31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474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nique </a:t>
                      </a:r>
                      <a:r>
                        <a:rPr b="1" lang="en-US" sz="12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77,33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11,32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,483,25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,014,10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416160">
                <a:tc rowSpan="2"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erfect matchin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otal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,080,87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,526,40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,837,72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,780,85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4064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nique </a:t>
                      </a:r>
                      <a:r>
                        <a:rPr b="1" lang="en-US" sz="12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49,72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88,34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13,01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,333,80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2" name="矩形 2"/>
          <p:cNvSpPr/>
          <p:nvPr/>
        </p:nvSpPr>
        <p:spPr>
          <a:xfrm>
            <a:off x="4583160" y="250920"/>
            <a:ext cx="2239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4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l table 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矩形 2"/>
          <p:cNvSpPr/>
          <p:nvPr/>
        </p:nvSpPr>
        <p:spPr>
          <a:xfrm>
            <a:off x="169560" y="3924360"/>
            <a:ext cx="34560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2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  </a:t>
            </a: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“Unique” is the number of different sequences found within libraries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矩形 2"/>
          <p:cNvSpPr/>
          <p:nvPr/>
        </p:nvSpPr>
        <p:spPr>
          <a:xfrm>
            <a:off x="209520" y="4140360"/>
            <a:ext cx="6459480" cy="533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2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  </a:t>
            </a: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“Unique” is the number that perfectly matching to at least one location in the genome and signature matching tRNAs, rRNAs, sRNAs,       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Bef>
                <a:spcPts val="2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   </a:t>
            </a: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or snoRNAs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4-02T05:19:20Z</dcterms:created>
  <dc:creator>MC SYSTEM</dc:creator>
  <dc:description/>
  <dc:language>en-US</dc:language>
  <cp:lastModifiedBy>MC SYSTEM</cp:lastModifiedBy>
  <dcterms:modified xsi:type="dcterms:W3CDTF">2011-05-17T02:26:33Z</dcterms:modified>
  <cp:revision>8</cp:revision>
  <dc:subject/>
  <dc:title>幻灯片 1</dc:title>
</cp:coreProperties>
</file>